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878" y="6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F7D655-D1A5-5ADC-7F7D-4872B48C1A1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CDF2578-7100-AF1A-D85F-6CA611B07D0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C5AE45-E95F-FE14-59BE-C2C74A1473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E4F4F-EBE2-4BE5-8615-00F85E88E305}" type="datetimeFigureOut">
              <a:rPr lang="en-IN" smtClean="0"/>
              <a:t>27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678361-E26A-2992-05F3-269442D4E6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51B34F-4363-487C-A25C-3CB10A72A6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7971E-2A79-43F9-A8BA-71F113A3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226365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2FA013-259C-51D9-1DAD-1C02913549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1576342-04D0-C7CD-A486-C43DFF6FCB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8E12A3-0CAE-132C-622A-842B842721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E4F4F-EBE2-4BE5-8615-00F85E88E305}" type="datetimeFigureOut">
              <a:rPr lang="en-IN" smtClean="0"/>
              <a:t>27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EE2309-D894-B241-C428-BB96019E4A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3F0AB4-83B6-A565-F7A9-085B8CB2AD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7971E-2A79-43F9-A8BA-71F113A3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05027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433FDFB-C9DD-B5F1-BE34-4B99B88D7C8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0AF3BBC-9AEB-39A8-9AF3-0B877BF342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04F0DD-634E-1A17-9EA6-20FE39AEF4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E4F4F-EBE2-4BE5-8615-00F85E88E305}" type="datetimeFigureOut">
              <a:rPr lang="en-IN" smtClean="0"/>
              <a:t>27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3EC5FC-575B-928F-3F46-3C531810B3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E2C433-E748-A9F9-F125-781BA96BCE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7971E-2A79-43F9-A8BA-71F113A3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6367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033760-7E23-AA22-9526-A3F17D07DD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0D1767-1ED0-DC59-C475-6A8FDBA9146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0F327C-BF45-C256-BF0C-F66EBC0DD8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E4F4F-EBE2-4BE5-8615-00F85E88E305}" type="datetimeFigureOut">
              <a:rPr lang="en-IN" smtClean="0"/>
              <a:t>27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B0BF39-BDA5-AB25-E85F-F70D90CEB8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F9F6A0-DFC9-E64A-0FDE-EAE878A33C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7971E-2A79-43F9-A8BA-71F113A3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69839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AAE4C3-98F4-9504-5B6F-DFEA2D8030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CACE38-95A3-6A15-18BB-93B10CEB87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EFF2E2-B6FD-458F-7C32-3E1A2ACA63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E4F4F-EBE2-4BE5-8615-00F85E88E305}" type="datetimeFigureOut">
              <a:rPr lang="en-IN" smtClean="0"/>
              <a:t>27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DFC95D-F9A3-8C30-B285-B8993DC237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57E433-E944-33E7-08A3-8D1AE70F9D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7971E-2A79-43F9-A8BA-71F113A3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39482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78A521-6EB6-16C7-843A-4F46107F41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4306A2-E347-2336-77CD-6C843824107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4070DE-A24F-D031-D566-5BDB5D2E2B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1B488B-278F-9A59-73EA-3C8C5309E9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E4F4F-EBE2-4BE5-8615-00F85E88E305}" type="datetimeFigureOut">
              <a:rPr lang="en-IN" smtClean="0"/>
              <a:t>27-12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C7E15D-EF44-9F5F-021D-05CEE321A6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A66D54A-5E78-A82E-8FF0-8F184F1658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7971E-2A79-43F9-A8BA-71F113A3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353653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52BBA9-B1B1-A5EC-6F37-D674FF2D52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550062C-BCB4-3CCE-A7F1-B02823931D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12AFADD-6AA5-E39E-4D40-07837221AF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F8A2600-EAF2-FC24-1AC6-0286819ADC0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F458716-64FE-E963-8B5F-7D6220EC810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57D28C2-F870-79B5-A8E5-002EAFF16C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E4F4F-EBE2-4BE5-8615-00F85E88E305}" type="datetimeFigureOut">
              <a:rPr lang="en-IN" smtClean="0"/>
              <a:t>27-12-2024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172EBA8-7D3B-B611-DBD4-C8079866AA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BF7FE02-4D7F-897A-D6F0-5D83977643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7971E-2A79-43F9-A8BA-71F113A3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68223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C88E51-0BE5-0881-D5B0-EC712066CB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4B3F507-A972-A339-6A9C-BB070456AB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E4F4F-EBE2-4BE5-8615-00F85E88E305}" type="datetimeFigureOut">
              <a:rPr lang="en-IN" smtClean="0"/>
              <a:t>27-12-2024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86D9814-3CD9-9901-D448-62802D5E66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40FB363-0506-4325-6DD7-77F4AF3AFE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7971E-2A79-43F9-A8BA-71F113A3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600719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D2ECA96-7C9B-01AF-06A2-428CC03EFE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E4F4F-EBE2-4BE5-8615-00F85E88E305}" type="datetimeFigureOut">
              <a:rPr lang="en-IN" smtClean="0"/>
              <a:t>27-12-2024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F03E434-FD9A-C983-D7D2-3569206BEB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6A8C71E-57F1-FEF5-F6CE-BD74891BE1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7971E-2A79-43F9-A8BA-71F113A3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020136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0BEDB3-2750-4A1D-2D8B-40BD0D7CD2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B48B5D-7260-B212-8327-E5D82A10A63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57CC54A-D6DD-1A03-4B9D-76126A09BF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508D67-D469-5CED-8422-374E2D0A22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E4F4F-EBE2-4BE5-8615-00F85E88E305}" type="datetimeFigureOut">
              <a:rPr lang="en-IN" smtClean="0"/>
              <a:t>27-12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C4946E-5354-4432-949A-047C6184AD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B80EE5-9BAC-7DF5-1127-06F9E948E8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7971E-2A79-43F9-A8BA-71F113A3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367993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876F89-F3BE-5D39-BE97-A75A81703E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4FF8F76-4596-2DF7-A5F1-E74E457499C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C09817B-EAE0-05F5-94C0-C7EA6671E5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491E4E-97E5-ABE6-20A3-CDD0C89BE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DE4F4F-EBE2-4BE5-8615-00F85E88E305}" type="datetimeFigureOut">
              <a:rPr lang="en-IN" smtClean="0"/>
              <a:t>27-12-2024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2CD1D4-5D53-C59F-9C04-A1EDF22F54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EE2C6C-DC95-03D7-0065-BAC7413B10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17971E-2A79-43F9-A8BA-71F113A3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46929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7DA85CA-8CAB-EB1B-CE76-1CA96BD06A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3708D5-6852-92CD-40EC-60FC58CCB7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643199-2471-CDF7-82EE-93DE8C4B6A7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DE4F4F-EBE2-4BE5-8615-00F85E88E305}" type="datetimeFigureOut">
              <a:rPr lang="en-IN" smtClean="0"/>
              <a:t>27-12-2024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8F3BB7-EB35-1A76-7141-4EBC3119C3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6C006C-24E0-0BB4-D6A1-C17B543620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17971E-2A79-43F9-A8BA-71F113A3485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737781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2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E343AEE5-E63C-8355-7E5A-00F1B36CE767}"/>
              </a:ext>
            </a:extLst>
          </p:cNvPr>
          <p:cNvSpPr txBox="1"/>
          <p:nvPr/>
        </p:nvSpPr>
        <p:spPr>
          <a:xfrm>
            <a:off x="2862029" y="437215"/>
            <a:ext cx="136287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800" b="1" dirty="0">
                <a:latin typeface="Arial" panose="020B0604020202020204" pitchFamily="34" charset="0"/>
                <a:cs typeface="Arial" panose="020B0604020202020204" pitchFamily="34" charset="0"/>
              </a:rPr>
              <a:t>4hrs pi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6C2B2E3-CB5A-EE40-1E33-FA9508F217B6}"/>
              </a:ext>
            </a:extLst>
          </p:cNvPr>
          <p:cNvSpPr txBox="1"/>
          <p:nvPr/>
        </p:nvSpPr>
        <p:spPr>
          <a:xfrm>
            <a:off x="8191042" y="437215"/>
            <a:ext cx="161357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800" b="1" dirty="0">
                <a:latin typeface="Arial" panose="020B0604020202020204" pitchFamily="34" charset="0"/>
                <a:cs typeface="Arial" panose="020B0604020202020204" pitchFamily="34" charset="0"/>
              </a:rPr>
              <a:t>24hrs pi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9609E4E-EE6C-8D85-4975-419B5DECAA7B}"/>
              </a:ext>
            </a:extLst>
          </p:cNvPr>
          <p:cNvSpPr txBox="1"/>
          <p:nvPr/>
        </p:nvSpPr>
        <p:spPr>
          <a:xfrm>
            <a:off x="5319505" y="-22425"/>
            <a:ext cx="207967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28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D-S-GFP</a:t>
            </a:r>
            <a:endParaRPr lang="en-IN" sz="2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IN" sz="28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D-R-RFP</a:t>
            </a:r>
          </a:p>
        </p:txBody>
      </p:sp>
      <p:pic>
        <p:nvPicPr>
          <p:cNvPr id="4" name="24 hr avi">
            <a:hlinkClick r:id="" action="ppaction://media"/>
            <a:extLst>
              <a:ext uri="{FF2B5EF4-FFF2-40B4-BE49-F238E27FC236}">
                <a16:creationId xmlns:a16="http://schemas.microsoft.com/office/drawing/2014/main" id="{31BA6928-5F0F-6A96-D888-D2B28EFC130F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6895299" y="1007095"/>
            <a:ext cx="4505425" cy="4515879"/>
          </a:xfrm>
          <a:prstGeom prst="rect">
            <a:avLst/>
          </a:prstGeom>
        </p:spPr>
      </p:pic>
      <p:pic>
        <p:nvPicPr>
          <p:cNvPr id="5" name="4hr avi">
            <a:hlinkClick r:id="" action="ppaction://media"/>
            <a:extLst>
              <a:ext uri="{FF2B5EF4-FFF2-40B4-BE49-F238E27FC236}">
                <a16:creationId xmlns:a16="http://schemas.microsoft.com/office/drawing/2014/main" id="{E56A2590-3D02-884F-6E37-7360A3ED1099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1436367" y="1007095"/>
            <a:ext cx="4505425" cy="451587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4EAEEF6-7FB0-F258-B60B-0BD871B1F7A6}"/>
              </a:ext>
            </a:extLst>
          </p:cNvPr>
          <p:cNvSpPr txBox="1"/>
          <p:nvPr/>
        </p:nvSpPr>
        <p:spPr>
          <a:xfrm>
            <a:off x="1" y="5731503"/>
            <a:ext cx="1219199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IN" sz="1800" b="1" kern="10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1 Video: </a:t>
            </a:r>
            <a:r>
              <a:rPr lang="en-IN" sz="18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creased proliferation rate of LD-R-RFP compared to LD-S-GFP. </a:t>
            </a:r>
            <a:r>
              <a:rPr lang="en-IN" sz="18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ideography (20 frames/sec) showing active invasion of LD-S-GFP and LD-R-RFP metacyclic promastigotes in peritoneal macrophages at 4hrs pi (left panel). The right panel shows LD-R-RFP amastigotes outcompeting LD-S-GFP amastigotes at 24hrs pi.</a:t>
            </a:r>
            <a:endParaRPr lang="en-IN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IN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66FAF8B-D417-2736-F3BC-C735FFB7E63E}"/>
              </a:ext>
            </a:extLst>
          </p:cNvPr>
          <p:cNvSpPr txBox="1"/>
          <p:nvPr/>
        </p:nvSpPr>
        <p:spPr>
          <a:xfrm>
            <a:off x="22356" y="58904"/>
            <a:ext cx="21255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3600" b="1">
                <a:latin typeface="Arial" panose="020B0604020202020204" pitchFamily="34" charset="0"/>
                <a:cs typeface="Arial" panose="020B0604020202020204" pitchFamily="34" charset="0"/>
              </a:rPr>
              <a:t>S1 Video</a:t>
            </a:r>
            <a:endParaRPr lang="en-IN" sz="3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451610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505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  <p:par>
                                <p:cTn id="7" presetID="1" presetClass="mediacall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8" dur="505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9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10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1" fill="hold">
                      <p:stCondLst>
                        <p:cond delay="0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4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15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59</Words>
  <Application>Microsoft Office PowerPoint</Application>
  <PresentationFormat>Widescreen</PresentationFormat>
  <Paragraphs>6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Video S1</dc:title>
  <dc:creator>Souradeepa Ghosh</dc:creator>
  <cp:lastModifiedBy>Souradeepa Ghosh</cp:lastModifiedBy>
  <cp:revision>5</cp:revision>
  <dcterms:created xsi:type="dcterms:W3CDTF">2024-04-18T07:49:49Z</dcterms:created>
  <dcterms:modified xsi:type="dcterms:W3CDTF">2024-12-27T07:24:52Z</dcterms:modified>
</cp:coreProperties>
</file>